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4" r:id="rId2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792">
          <p15:clr>
            <a:srgbClr val="A4A3A4"/>
          </p15:clr>
        </p15:guide>
        <p15:guide id="2" pos="312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hwsedero" initials="h" lastIdx="2" clrIdx="0"/>
  <p:cmAuthor id="1" name="Soundarya Srirangan" initials="SS" lastIdx="9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CECE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843" autoAdjust="0"/>
    <p:restoredTop sz="99856" autoAdjust="0"/>
  </p:normalViewPr>
  <p:slideViewPr>
    <p:cSldViewPr>
      <p:cViewPr varScale="1">
        <p:scale>
          <a:sx n="53" d="100"/>
          <a:sy n="53" d="100"/>
        </p:scale>
        <p:origin x="1952" y="48"/>
      </p:cViewPr>
      <p:guideLst>
        <p:guide orient="horz" pos="3792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53" d="100"/>
          <a:sy n="53" d="100"/>
        </p:scale>
        <p:origin x="2624" y="28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userdata\bpj483\Desktop\Total_Lipid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Soundarya\Desktop\ff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0368662798729146E-2"/>
          <c:y val="3.7374135051300411E-2"/>
          <c:w val="0.9054530080291685"/>
          <c:h val="0.84890132091893222"/>
        </c:manualLayout>
      </c:layout>
      <c:barChart>
        <c:barDir val="col"/>
        <c:grouping val="clustered"/>
        <c:varyColors val="0"/>
        <c:ser>
          <c:idx val="0"/>
          <c:order val="0"/>
          <c:tx>
            <c:v>saturated free FA</c:v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figure 8 sat unsat'!$Z$119:$AS$119</c:f>
                <c:numCache>
                  <c:formatCode>General</c:formatCode>
                  <c:ptCount val="20"/>
                  <c:pt idx="0">
                    <c:v>0.25691344255644155</c:v>
                  </c:pt>
                  <c:pt idx="1">
                    <c:v>0.58129529378043954</c:v>
                  </c:pt>
                  <c:pt idx="2">
                    <c:v>1.286217263217668</c:v>
                  </c:pt>
                  <c:pt idx="3">
                    <c:v>0.83881490032041073</c:v>
                  </c:pt>
                  <c:pt idx="4">
                    <c:v>0.77771632286103554</c:v>
                  </c:pt>
                  <c:pt idx="5">
                    <c:v>0.80506151265383885</c:v>
                  </c:pt>
                  <c:pt idx="6">
                    <c:v>1.7229704680380933</c:v>
                  </c:pt>
                  <c:pt idx="7">
                    <c:v>3.7039037610857672</c:v>
                  </c:pt>
                  <c:pt idx="8">
                    <c:v>0.97021380856175821</c:v>
                  </c:pt>
                  <c:pt idx="9">
                    <c:v>1.9492695331069487</c:v>
                  </c:pt>
                  <c:pt idx="10">
                    <c:v>0.38958214842948863</c:v>
                  </c:pt>
                  <c:pt idx="11">
                    <c:v>0.77566359260150286</c:v>
                  </c:pt>
                  <c:pt idx="12">
                    <c:v>0.61373910432363665</c:v>
                  </c:pt>
                  <c:pt idx="13">
                    <c:v>2.089073969257683</c:v>
                  </c:pt>
                  <c:pt idx="14">
                    <c:v>1.1931658681438608</c:v>
                  </c:pt>
                  <c:pt idx="15">
                    <c:v>0.97467121936494783</c:v>
                  </c:pt>
                  <c:pt idx="16">
                    <c:v>1.5160760839730743</c:v>
                  </c:pt>
                  <c:pt idx="17">
                    <c:v>3.6367806145059678</c:v>
                  </c:pt>
                  <c:pt idx="18">
                    <c:v>2.8893520682480114</c:v>
                  </c:pt>
                  <c:pt idx="19">
                    <c:v>4.5276804816135119</c:v>
                  </c:pt>
                </c:numCache>
              </c:numRef>
            </c:plus>
            <c:minus>
              <c:numRef>
                <c:f>'figure 8 sat unsat'!$Z$119:$AS$119</c:f>
                <c:numCache>
                  <c:formatCode>General</c:formatCode>
                  <c:ptCount val="20"/>
                  <c:pt idx="0">
                    <c:v>0.25691344255644155</c:v>
                  </c:pt>
                  <c:pt idx="1">
                    <c:v>0.58129529378043954</c:v>
                  </c:pt>
                  <c:pt idx="2">
                    <c:v>1.286217263217668</c:v>
                  </c:pt>
                  <c:pt idx="3">
                    <c:v>0.83881490032041073</c:v>
                  </c:pt>
                  <c:pt idx="4">
                    <c:v>0.77771632286103554</c:v>
                  </c:pt>
                  <c:pt idx="5">
                    <c:v>0.80506151265383885</c:v>
                  </c:pt>
                  <c:pt idx="6">
                    <c:v>1.7229704680380933</c:v>
                  </c:pt>
                  <c:pt idx="7">
                    <c:v>3.7039037610857672</c:v>
                  </c:pt>
                  <c:pt idx="8">
                    <c:v>0.97021380856175821</c:v>
                  </c:pt>
                  <c:pt idx="9">
                    <c:v>1.9492695331069487</c:v>
                  </c:pt>
                  <c:pt idx="10">
                    <c:v>0.38958214842948863</c:v>
                  </c:pt>
                  <c:pt idx="11">
                    <c:v>0.77566359260150286</c:v>
                  </c:pt>
                  <c:pt idx="12">
                    <c:v>0.61373910432363665</c:v>
                  </c:pt>
                  <c:pt idx="13">
                    <c:v>2.089073969257683</c:v>
                  </c:pt>
                  <c:pt idx="14">
                    <c:v>1.1931658681438608</c:v>
                  </c:pt>
                  <c:pt idx="15">
                    <c:v>0.97467121936494783</c:v>
                  </c:pt>
                  <c:pt idx="16">
                    <c:v>1.5160760839730743</c:v>
                  </c:pt>
                  <c:pt idx="17">
                    <c:v>3.6367806145059678</c:v>
                  </c:pt>
                  <c:pt idx="18">
                    <c:v>2.8893520682480114</c:v>
                  </c:pt>
                  <c:pt idx="19">
                    <c:v>4.5276804816135119</c:v>
                  </c:pt>
                </c:numCache>
              </c:numRef>
            </c:minus>
          </c:errBars>
          <c:cat>
            <c:multiLvlStrRef>
              <c:f>'figure 8 sat unsat'!$C$3:$V$4</c:f>
              <c:multiLvlStrCache>
                <c:ptCount val="20"/>
                <c:lvl>
                  <c:pt idx="0">
                    <c:v>6 h</c:v>
                  </c:pt>
                  <c:pt idx="1">
                    <c:v>16 h</c:v>
                  </c:pt>
                  <c:pt idx="2">
                    <c:v>30 h</c:v>
                  </c:pt>
                  <c:pt idx="3">
                    <c:v>42 h</c:v>
                  </c:pt>
                  <c:pt idx="4">
                    <c:v>54 h</c:v>
                  </c:pt>
                  <c:pt idx="5">
                    <c:v>6 h</c:v>
                  </c:pt>
                  <c:pt idx="6">
                    <c:v>16 h</c:v>
                  </c:pt>
                  <c:pt idx="7">
                    <c:v>30 h</c:v>
                  </c:pt>
                  <c:pt idx="8">
                    <c:v>42 h</c:v>
                  </c:pt>
                  <c:pt idx="9">
                    <c:v>54 h</c:v>
                  </c:pt>
                  <c:pt idx="10">
                    <c:v>6 h</c:v>
                  </c:pt>
                  <c:pt idx="11">
                    <c:v>16 h</c:v>
                  </c:pt>
                  <c:pt idx="12">
                    <c:v>30 h</c:v>
                  </c:pt>
                  <c:pt idx="13">
                    <c:v>42 h</c:v>
                  </c:pt>
                  <c:pt idx="14">
                    <c:v>54 h</c:v>
                  </c:pt>
                  <c:pt idx="15">
                    <c:v>6 h</c:v>
                  </c:pt>
                  <c:pt idx="16">
                    <c:v>16 h</c:v>
                  </c:pt>
                  <c:pt idx="17">
                    <c:v>30 h</c:v>
                  </c:pt>
                  <c:pt idx="18">
                    <c:v>42 h</c:v>
                  </c:pt>
                  <c:pt idx="19">
                    <c:v>54 h</c:v>
                  </c:pt>
                </c:lvl>
                <c:lvl>
                  <c:pt idx="0">
                    <c:v>LD  25°C</c:v>
                  </c:pt>
                  <c:pt idx="5">
                    <c:v>LL 25°C</c:v>
                  </c:pt>
                  <c:pt idx="10">
                    <c:v>LD 35°C</c:v>
                  </c:pt>
                  <c:pt idx="15">
                    <c:v>LL 35°C</c:v>
                  </c:pt>
                </c:lvl>
              </c:multiLvlStrCache>
            </c:multiLvlStrRef>
          </c:cat>
          <c:val>
            <c:numRef>
              <c:f>'figure 8 sat unsat'!$C$109:$V$109</c:f>
              <c:numCache>
                <c:formatCode>0.0</c:formatCode>
                <c:ptCount val="20"/>
                <c:pt idx="0">
                  <c:v>4.5814223015062687</c:v>
                </c:pt>
                <c:pt idx="1">
                  <c:v>8.9358452863568232</c:v>
                </c:pt>
                <c:pt idx="2">
                  <c:v>10.598398293972167</c:v>
                </c:pt>
                <c:pt idx="3">
                  <c:v>8.849335917760019</c:v>
                </c:pt>
                <c:pt idx="4">
                  <c:v>5.525929783464572</c:v>
                </c:pt>
                <c:pt idx="5">
                  <c:v>5.6771773424056144</c:v>
                </c:pt>
                <c:pt idx="6">
                  <c:v>12.278377932308969</c:v>
                </c:pt>
                <c:pt idx="7">
                  <c:v>14.511309407042669</c:v>
                </c:pt>
                <c:pt idx="8">
                  <c:v>9.9960406137087023</c:v>
                </c:pt>
                <c:pt idx="9">
                  <c:v>8.9512634151971309</c:v>
                </c:pt>
                <c:pt idx="10">
                  <c:v>3.418772033047734</c:v>
                </c:pt>
                <c:pt idx="11">
                  <c:v>7.2464159315348828</c:v>
                </c:pt>
                <c:pt idx="12">
                  <c:v>7.4288394316076314</c:v>
                </c:pt>
                <c:pt idx="13">
                  <c:v>8.5818079294117631</c:v>
                </c:pt>
                <c:pt idx="14">
                  <c:v>6.2692030566572239</c:v>
                </c:pt>
                <c:pt idx="15">
                  <c:v>8.5866102388758758</c:v>
                </c:pt>
                <c:pt idx="16">
                  <c:v>15.883755306445398</c:v>
                </c:pt>
                <c:pt idx="17">
                  <c:v>10.524470392945787</c:v>
                </c:pt>
                <c:pt idx="18">
                  <c:v>12.558579158169945</c:v>
                </c:pt>
                <c:pt idx="19">
                  <c:v>15.128929749681518</c:v>
                </c:pt>
              </c:numCache>
            </c:numRef>
          </c:val>
        </c:ser>
        <c:ser>
          <c:idx val="1"/>
          <c:order val="1"/>
          <c:tx>
            <c:v>unsaturated free FA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figure 8 sat unsat'!$Z$120:$AS$120</c:f>
                <c:numCache>
                  <c:formatCode>General</c:formatCode>
                  <c:ptCount val="20"/>
                  <c:pt idx="0">
                    <c:v>8.0448554824414664</c:v>
                  </c:pt>
                  <c:pt idx="1">
                    <c:v>7.7006422353967903</c:v>
                  </c:pt>
                  <c:pt idx="2">
                    <c:v>7.9610115982693008</c:v>
                  </c:pt>
                  <c:pt idx="3">
                    <c:v>16.102991663008876</c:v>
                  </c:pt>
                  <c:pt idx="4">
                    <c:v>21.847665938584374</c:v>
                  </c:pt>
                  <c:pt idx="5">
                    <c:v>11.931673846169151</c:v>
                  </c:pt>
                  <c:pt idx="6">
                    <c:v>24.292866830087487</c:v>
                  </c:pt>
                  <c:pt idx="7">
                    <c:v>30.175431140470206</c:v>
                  </c:pt>
                  <c:pt idx="8">
                    <c:v>17.726154925252601</c:v>
                  </c:pt>
                  <c:pt idx="9">
                    <c:v>15.752700481045272</c:v>
                  </c:pt>
                  <c:pt idx="10">
                    <c:v>15.027131612807542</c:v>
                  </c:pt>
                  <c:pt idx="11">
                    <c:v>2.0549477941641836</c:v>
                  </c:pt>
                  <c:pt idx="12">
                    <c:v>21.056317322214728</c:v>
                  </c:pt>
                  <c:pt idx="13">
                    <c:v>24.99859616585044</c:v>
                  </c:pt>
                  <c:pt idx="14">
                    <c:v>7.8258454646903663</c:v>
                  </c:pt>
                  <c:pt idx="15">
                    <c:v>5.2121597332231735</c:v>
                  </c:pt>
                  <c:pt idx="16">
                    <c:v>17.840437098790986</c:v>
                  </c:pt>
                  <c:pt idx="17">
                    <c:v>7.3332772928999121</c:v>
                  </c:pt>
                  <c:pt idx="18">
                    <c:v>9.576178343534437</c:v>
                  </c:pt>
                  <c:pt idx="19">
                    <c:v>26.987206689376851</c:v>
                  </c:pt>
                </c:numCache>
              </c:numRef>
            </c:plus>
            <c:minus>
              <c:numRef>
                <c:f>'figure 8 sat unsat'!$Z$120:$AS$120</c:f>
                <c:numCache>
                  <c:formatCode>General</c:formatCode>
                  <c:ptCount val="20"/>
                  <c:pt idx="0">
                    <c:v>8.0448554824414664</c:v>
                  </c:pt>
                  <c:pt idx="1">
                    <c:v>7.7006422353967903</c:v>
                  </c:pt>
                  <c:pt idx="2">
                    <c:v>7.9610115982693008</c:v>
                  </c:pt>
                  <c:pt idx="3">
                    <c:v>16.102991663008876</c:v>
                  </c:pt>
                  <c:pt idx="4">
                    <c:v>21.847665938584374</c:v>
                  </c:pt>
                  <c:pt idx="5">
                    <c:v>11.931673846169151</c:v>
                  </c:pt>
                  <c:pt idx="6">
                    <c:v>24.292866830087487</c:v>
                  </c:pt>
                  <c:pt idx="7">
                    <c:v>30.175431140470206</c:v>
                  </c:pt>
                  <c:pt idx="8">
                    <c:v>17.726154925252601</c:v>
                  </c:pt>
                  <c:pt idx="9">
                    <c:v>15.752700481045272</c:v>
                  </c:pt>
                  <c:pt idx="10">
                    <c:v>15.027131612807542</c:v>
                  </c:pt>
                  <c:pt idx="11">
                    <c:v>2.0549477941641836</c:v>
                  </c:pt>
                  <c:pt idx="12">
                    <c:v>21.056317322214728</c:v>
                  </c:pt>
                  <c:pt idx="13">
                    <c:v>24.99859616585044</c:v>
                  </c:pt>
                  <c:pt idx="14">
                    <c:v>7.8258454646903663</c:v>
                  </c:pt>
                  <c:pt idx="15">
                    <c:v>5.2121597332231735</c:v>
                  </c:pt>
                  <c:pt idx="16">
                    <c:v>17.840437098790986</c:v>
                  </c:pt>
                  <c:pt idx="17">
                    <c:v>7.3332772928999121</c:v>
                  </c:pt>
                  <c:pt idx="18">
                    <c:v>9.576178343534437</c:v>
                  </c:pt>
                  <c:pt idx="19">
                    <c:v>26.987206689376851</c:v>
                  </c:pt>
                </c:numCache>
              </c:numRef>
            </c:minus>
          </c:errBars>
          <c:cat>
            <c:multiLvlStrRef>
              <c:f>'figure 8 sat unsat'!$C$3:$V$4</c:f>
              <c:multiLvlStrCache>
                <c:ptCount val="20"/>
                <c:lvl>
                  <c:pt idx="0">
                    <c:v>6 h</c:v>
                  </c:pt>
                  <c:pt idx="1">
                    <c:v>16 h</c:v>
                  </c:pt>
                  <c:pt idx="2">
                    <c:v>30 h</c:v>
                  </c:pt>
                  <c:pt idx="3">
                    <c:v>42 h</c:v>
                  </c:pt>
                  <c:pt idx="4">
                    <c:v>54 h</c:v>
                  </c:pt>
                  <c:pt idx="5">
                    <c:v>6 h</c:v>
                  </c:pt>
                  <c:pt idx="6">
                    <c:v>16 h</c:v>
                  </c:pt>
                  <c:pt idx="7">
                    <c:v>30 h</c:v>
                  </c:pt>
                  <c:pt idx="8">
                    <c:v>42 h</c:v>
                  </c:pt>
                  <c:pt idx="9">
                    <c:v>54 h</c:v>
                  </c:pt>
                  <c:pt idx="10">
                    <c:v>6 h</c:v>
                  </c:pt>
                  <c:pt idx="11">
                    <c:v>16 h</c:v>
                  </c:pt>
                  <c:pt idx="12">
                    <c:v>30 h</c:v>
                  </c:pt>
                  <c:pt idx="13">
                    <c:v>42 h</c:v>
                  </c:pt>
                  <c:pt idx="14">
                    <c:v>54 h</c:v>
                  </c:pt>
                  <c:pt idx="15">
                    <c:v>6 h</c:v>
                  </c:pt>
                  <c:pt idx="16">
                    <c:v>16 h</c:v>
                  </c:pt>
                  <c:pt idx="17">
                    <c:v>30 h</c:v>
                  </c:pt>
                  <c:pt idx="18">
                    <c:v>42 h</c:v>
                  </c:pt>
                  <c:pt idx="19">
                    <c:v>54 h</c:v>
                  </c:pt>
                </c:lvl>
                <c:lvl>
                  <c:pt idx="0">
                    <c:v>LD  25°C</c:v>
                  </c:pt>
                  <c:pt idx="5">
                    <c:v>LL 25°C</c:v>
                  </c:pt>
                  <c:pt idx="10">
                    <c:v>LD 35°C</c:v>
                  </c:pt>
                  <c:pt idx="15">
                    <c:v>LL 35°C</c:v>
                  </c:pt>
                </c:lvl>
              </c:multiLvlStrCache>
            </c:multiLvlStrRef>
          </c:cat>
          <c:val>
            <c:numRef>
              <c:f>'figure 8 sat unsat'!$C$110:$V$110</c:f>
              <c:numCache>
                <c:formatCode>0.0</c:formatCode>
                <c:ptCount val="20"/>
                <c:pt idx="0">
                  <c:v>26.632497407692195</c:v>
                </c:pt>
                <c:pt idx="1">
                  <c:v>46.304880306446741</c:v>
                </c:pt>
                <c:pt idx="2">
                  <c:v>55.046845230293627</c:v>
                </c:pt>
                <c:pt idx="3">
                  <c:v>92.935182219451264</c:v>
                </c:pt>
                <c:pt idx="4">
                  <c:v>39.008542190944915</c:v>
                </c:pt>
                <c:pt idx="5">
                  <c:v>30.771204543459174</c:v>
                </c:pt>
                <c:pt idx="6">
                  <c:v>55.827685894933545</c:v>
                </c:pt>
                <c:pt idx="7">
                  <c:v>59.187280883318358</c:v>
                </c:pt>
                <c:pt idx="8">
                  <c:v>47.13089196817625</c:v>
                </c:pt>
                <c:pt idx="9">
                  <c:v>78.745642437275976</c:v>
                </c:pt>
                <c:pt idx="10">
                  <c:v>38.793479208486332</c:v>
                </c:pt>
                <c:pt idx="11">
                  <c:v>38.239777576186043</c:v>
                </c:pt>
                <c:pt idx="12">
                  <c:v>54.794746960217971</c:v>
                </c:pt>
                <c:pt idx="13">
                  <c:v>137.5276011503268</c:v>
                </c:pt>
                <c:pt idx="14">
                  <c:v>41.589687535410725</c:v>
                </c:pt>
                <c:pt idx="15">
                  <c:v>29.503534238875865</c:v>
                </c:pt>
                <c:pt idx="16">
                  <c:v>55.821960196835199</c:v>
                </c:pt>
                <c:pt idx="17">
                  <c:v>66.944785319399102</c:v>
                </c:pt>
                <c:pt idx="18">
                  <c:v>62.947058903050106</c:v>
                </c:pt>
                <c:pt idx="19">
                  <c:v>113.3232807898089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25927424"/>
        <c:axId val="225927816"/>
      </c:barChart>
      <c:catAx>
        <c:axId val="22592742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b="0"/>
            </a:pPr>
            <a:endParaRPr lang="en-US"/>
          </a:p>
        </c:txPr>
        <c:crossAx val="225927816"/>
        <c:crosses val="autoZero"/>
        <c:auto val="1"/>
        <c:lblAlgn val="ctr"/>
        <c:lblOffset val="100"/>
        <c:noMultiLvlLbl val="0"/>
      </c:catAx>
      <c:valAx>
        <c:axId val="22592781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 dirty="0"/>
                  <a:t>Free fatty </a:t>
                </a:r>
                <a:r>
                  <a:rPr lang="en-US" b="0" dirty="0" smtClean="0"/>
                  <a:t>acids</a:t>
                </a:r>
                <a:r>
                  <a:rPr lang="en-US" b="0" baseline="0" dirty="0" smtClean="0"/>
                  <a:t> (</a:t>
                </a:r>
                <a:r>
                  <a:rPr lang="en-US" b="0" dirty="0" smtClean="0"/>
                  <a:t>µg)/million</a:t>
                </a:r>
                <a:r>
                  <a:rPr lang="en-US" b="0" baseline="0" dirty="0" smtClean="0"/>
                  <a:t> cells</a:t>
                </a:r>
                <a:endParaRPr lang="en-US" b="0" dirty="0"/>
              </a:p>
            </c:rich>
          </c:tx>
          <c:layout>
            <c:manualLayout>
              <c:xMode val="edge"/>
              <c:yMode val="edge"/>
              <c:x val="7.3429958979678439E-3"/>
              <c:y val="0.19397124049325221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b="0"/>
            </a:pPr>
            <a:endParaRPr lang="en-US"/>
          </a:p>
        </c:txPr>
        <c:crossAx val="22592742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1628747064511673"/>
          <c:y val="4.5096635647816824E-2"/>
          <c:w val="0.22110823318137862"/>
          <c:h val="0.11260289906943451"/>
        </c:manualLayout>
      </c:layout>
      <c:overlay val="0"/>
      <c:txPr>
        <a:bodyPr/>
        <a:lstStyle/>
        <a:p>
          <a:pPr>
            <a:defRPr sz="800" b="0"/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txPr>
    <a:bodyPr/>
    <a:lstStyle/>
    <a:p>
      <a:pPr>
        <a:defRPr sz="800" b="1">
          <a:latin typeface="Helvetica" pitchFamily="34" charset="0"/>
          <a:cs typeface="Helvetica" pitchFamily="34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576654157899688"/>
          <c:y val="2.099614604787977E-2"/>
          <c:w val="0.82959747800120032"/>
          <c:h val="0.83949104621475612"/>
        </c:manualLayout>
      </c:layout>
      <c:scatterChart>
        <c:scatterStyle val="lineMarker"/>
        <c:varyColors val="0"/>
        <c:ser>
          <c:idx val="0"/>
          <c:order val="0"/>
          <c:tx>
            <c:strRef>
              <c:f>'figure 6 '!$A$110</c:f>
              <c:strCache>
                <c:ptCount val="1"/>
                <c:pt idx="0">
                  <c:v>LD 25°C</c:v>
                </c:pt>
              </c:strCache>
            </c:strRef>
          </c:tx>
          <c:spPr>
            <a:ln w="34925">
              <a:solidFill>
                <a:schemeClr val="tx2">
                  <a:lumMod val="60000"/>
                  <a:lumOff val="40000"/>
                </a:schemeClr>
              </a:solidFill>
              <a:prstDash val="sysDash"/>
            </a:ln>
          </c:spPr>
          <c:marker>
            <c:symbol val="diamond"/>
            <c:size val="9"/>
            <c:spPr>
              <a:solidFill>
                <a:schemeClr val="tx2">
                  <a:lumMod val="60000"/>
                  <a:lumOff val="40000"/>
                </a:schemeClr>
              </a:solidFill>
              <a:ln>
                <a:solidFill>
                  <a:schemeClr val="tx2">
                    <a:lumMod val="60000"/>
                    <a:lumOff val="40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ure 6 '!$I$110:$M$110</c:f>
                <c:numCache>
                  <c:formatCode>General</c:formatCode>
                  <c:ptCount val="5"/>
                  <c:pt idx="0">
                    <c:v>25.807817338683932</c:v>
                  </c:pt>
                  <c:pt idx="1">
                    <c:v>21.254802024134257</c:v>
                  </c:pt>
                  <c:pt idx="2">
                    <c:v>15.770419649865174</c:v>
                  </c:pt>
                  <c:pt idx="3">
                    <c:v>22.233063060272084</c:v>
                  </c:pt>
                  <c:pt idx="4">
                    <c:v>17.329487815893941</c:v>
                  </c:pt>
                </c:numCache>
              </c:numRef>
            </c:plus>
            <c:minus>
              <c:numRef>
                <c:f>'figure 6 '!$I$110:$M$110</c:f>
                <c:numCache>
                  <c:formatCode>General</c:formatCode>
                  <c:ptCount val="5"/>
                  <c:pt idx="0">
                    <c:v>25.807817338683932</c:v>
                  </c:pt>
                  <c:pt idx="1">
                    <c:v>21.254802024134257</c:v>
                  </c:pt>
                  <c:pt idx="2">
                    <c:v>15.770419649865174</c:v>
                  </c:pt>
                  <c:pt idx="3">
                    <c:v>22.233063060272084</c:v>
                  </c:pt>
                  <c:pt idx="4">
                    <c:v>17.329487815893941</c:v>
                  </c:pt>
                </c:numCache>
              </c:numRef>
            </c:minus>
          </c:errBars>
          <c:xVal>
            <c:numRef>
              <c:f>'figure 6 '!$B$109:$F$109</c:f>
              <c:numCache>
                <c:formatCode>General</c:formatCode>
                <c:ptCount val="5"/>
                <c:pt idx="0">
                  <c:v>6</c:v>
                </c:pt>
                <c:pt idx="1">
                  <c:v>16</c:v>
                </c:pt>
                <c:pt idx="2">
                  <c:v>30</c:v>
                </c:pt>
                <c:pt idx="3">
                  <c:v>40</c:v>
                </c:pt>
                <c:pt idx="4">
                  <c:v>54</c:v>
                </c:pt>
              </c:numCache>
            </c:numRef>
          </c:xVal>
          <c:yVal>
            <c:numRef>
              <c:f>'figure 6 '!$B$110:$F$110</c:f>
              <c:numCache>
                <c:formatCode>General</c:formatCode>
                <c:ptCount val="5"/>
                <c:pt idx="0">
                  <c:v>49.8667118217042</c:v>
                </c:pt>
                <c:pt idx="1">
                  <c:v>57.822990837492227</c:v>
                </c:pt>
                <c:pt idx="2">
                  <c:v>66.479664940209688</c:v>
                </c:pt>
                <c:pt idx="3">
                  <c:v>102.86189813780666</c:v>
                </c:pt>
                <c:pt idx="4">
                  <c:v>43.214489576848266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figure 6 '!$A$111</c:f>
              <c:strCache>
                <c:ptCount val="1"/>
                <c:pt idx="0">
                  <c:v>LL 25°C</c:v>
                </c:pt>
              </c:strCache>
            </c:strRef>
          </c:tx>
          <c:spPr>
            <a:ln w="38100">
              <a:solidFill>
                <a:schemeClr val="tx2">
                  <a:lumMod val="60000"/>
                  <a:lumOff val="40000"/>
                </a:schemeClr>
              </a:solidFill>
            </a:ln>
          </c:spPr>
          <c:marker>
            <c:symbol val="square"/>
            <c:size val="9"/>
            <c:spPr>
              <a:solidFill>
                <a:schemeClr val="tx2">
                  <a:lumMod val="60000"/>
                  <a:lumOff val="40000"/>
                </a:schemeClr>
              </a:solidFill>
              <a:ln>
                <a:solidFill>
                  <a:schemeClr val="tx2">
                    <a:lumMod val="60000"/>
                    <a:lumOff val="40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ure 6 '!$I$111:$M$111</c:f>
                <c:numCache>
                  <c:formatCode>General</c:formatCode>
                  <c:ptCount val="5"/>
                  <c:pt idx="0">
                    <c:v>12.700709369719473</c:v>
                  </c:pt>
                  <c:pt idx="1">
                    <c:v>50.032919000887048</c:v>
                  </c:pt>
                  <c:pt idx="2">
                    <c:v>31.646460133070342</c:v>
                  </c:pt>
                  <c:pt idx="3">
                    <c:v>17.287507780505436</c:v>
                  </c:pt>
                  <c:pt idx="4">
                    <c:v>14.205491988403642</c:v>
                  </c:pt>
                </c:numCache>
              </c:numRef>
            </c:plus>
            <c:minus>
              <c:numRef>
                <c:f>'figure 6 '!$I$111:$M$111</c:f>
                <c:numCache>
                  <c:formatCode>General</c:formatCode>
                  <c:ptCount val="5"/>
                  <c:pt idx="0">
                    <c:v>12.700709369719473</c:v>
                  </c:pt>
                  <c:pt idx="1">
                    <c:v>50.032919000887048</c:v>
                  </c:pt>
                  <c:pt idx="2">
                    <c:v>31.646460133070342</c:v>
                  </c:pt>
                  <c:pt idx="3">
                    <c:v>17.287507780505436</c:v>
                  </c:pt>
                  <c:pt idx="4">
                    <c:v>14.205491988403642</c:v>
                  </c:pt>
                </c:numCache>
              </c:numRef>
            </c:minus>
          </c:errBars>
          <c:xVal>
            <c:numRef>
              <c:f>'figure 6 '!$B$109:$F$109</c:f>
              <c:numCache>
                <c:formatCode>General</c:formatCode>
                <c:ptCount val="5"/>
                <c:pt idx="0">
                  <c:v>6</c:v>
                </c:pt>
                <c:pt idx="1">
                  <c:v>16</c:v>
                </c:pt>
                <c:pt idx="2">
                  <c:v>30</c:v>
                </c:pt>
                <c:pt idx="3">
                  <c:v>40</c:v>
                </c:pt>
                <c:pt idx="4">
                  <c:v>54</c:v>
                </c:pt>
              </c:numCache>
            </c:numRef>
          </c:xVal>
          <c:yVal>
            <c:numRef>
              <c:f>'figure 6 '!$B$111:$F$111</c:f>
              <c:numCache>
                <c:formatCode>0.0</c:formatCode>
                <c:ptCount val="5"/>
                <c:pt idx="0">
                  <c:v>33.514906898091525</c:v>
                </c:pt>
                <c:pt idx="1">
                  <c:v>70.894446819521676</c:v>
                </c:pt>
                <c:pt idx="2">
                  <c:v>73.689160786809509</c:v>
                </c:pt>
                <c:pt idx="3">
                  <c:v>56.809911580527356</c:v>
                </c:pt>
                <c:pt idx="4">
                  <c:v>88.095064349090691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figure 6 '!$A$112</c:f>
              <c:strCache>
                <c:ptCount val="1"/>
                <c:pt idx="0">
                  <c:v>LD 35°C</c:v>
                </c:pt>
              </c:strCache>
            </c:strRef>
          </c:tx>
          <c:spPr>
            <a:ln w="38100">
              <a:solidFill>
                <a:srgbClr val="FF0000"/>
              </a:solidFill>
              <a:prstDash val="sysDash"/>
            </a:ln>
          </c:spPr>
          <c:marker>
            <c:symbol val="triangle"/>
            <c:size val="9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ure 6 '!$I$112:$M$112</c:f>
                <c:numCache>
                  <c:formatCode>General</c:formatCode>
                  <c:ptCount val="5"/>
                  <c:pt idx="0">
                    <c:v>13.158630108540034</c:v>
                  </c:pt>
                  <c:pt idx="1">
                    <c:v>3.7998148015033117</c:v>
                  </c:pt>
                  <c:pt idx="2">
                    <c:v>23.333695514595014</c:v>
                  </c:pt>
                  <c:pt idx="3">
                    <c:v>23.192488872618547</c:v>
                  </c:pt>
                  <c:pt idx="4">
                    <c:v>8.1783957077359712</c:v>
                  </c:pt>
                </c:numCache>
              </c:numRef>
            </c:plus>
            <c:minus>
              <c:numRef>
                <c:f>'figure 6 '!$I$112:$M$112</c:f>
                <c:numCache>
                  <c:formatCode>General</c:formatCode>
                  <c:ptCount val="5"/>
                  <c:pt idx="0">
                    <c:v>13.158630108540034</c:v>
                  </c:pt>
                  <c:pt idx="1">
                    <c:v>3.7998148015033117</c:v>
                  </c:pt>
                  <c:pt idx="2">
                    <c:v>23.333695514595014</c:v>
                  </c:pt>
                  <c:pt idx="3">
                    <c:v>23.192488872618547</c:v>
                  </c:pt>
                  <c:pt idx="4">
                    <c:v>8.1783957077359712</c:v>
                  </c:pt>
                </c:numCache>
              </c:numRef>
            </c:minus>
          </c:errBars>
          <c:xVal>
            <c:numRef>
              <c:f>'figure 6 '!$B$109:$F$109</c:f>
              <c:numCache>
                <c:formatCode>General</c:formatCode>
                <c:ptCount val="5"/>
                <c:pt idx="0">
                  <c:v>6</c:v>
                </c:pt>
                <c:pt idx="1">
                  <c:v>16</c:v>
                </c:pt>
                <c:pt idx="2">
                  <c:v>30</c:v>
                </c:pt>
                <c:pt idx="3">
                  <c:v>40</c:v>
                </c:pt>
                <c:pt idx="4">
                  <c:v>54</c:v>
                </c:pt>
              </c:numCache>
            </c:numRef>
          </c:xVal>
          <c:yVal>
            <c:numRef>
              <c:f>'figure 6 '!$B$112:$F$112</c:f>
              <c:numCache>
                <c:formatCode>General</c:formatCode>
                <c:ptCount val="5"/>
                <c:pt idx="0">
                  <c:v>41.673928773529681</c:v>
                </c:pt>
                <c:pt idx="1">
                  <c:v>45.727478950223862</c:v>
                </c:pt>
                <c:pt idx="2">
                  <c:v>62.238225467875132</c:v>
                </c:pt>
                <c:pt idx="3">
                  <c:v>146.37978444584633</c:v>
                </c:pt>
                <c:pt idx="4">
                  <c:v>48.006332494553838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'figure 6 '!$A$113</c:f>
              <c:strCache>
                <c:ptCount val="1"/>
                <c:pt idx="0">
                  <c:v>LL 35°C</c:v>
                </c:pt>
              </c:strCache>
            </c:strRef>
          </c:tx>
          <c:spPr>
            <a:ln w="38100">
              <a:solidFill>
                <a:srgbClr val="FF0000"/>
              </a:solidFill>
            </a:ln>
          </c:spPr>
          <c:marker>
            <c:symbol val="circle"/>
            <c:size val="9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ure 6 '!$I$113:$M$113</c:f>
                <c:numCache>
                  <c:formatCode>General</c:formatCode>
                  <c:ptCount val="5"/>
                  <c:pt idx="0">
                    <c:v>10.600451086119579</c:v>
                  </c:pt>
                  <c:pt idx="1">
                    <c:v>11.589454873839351</c:v>
                  </c:pt>
                  <c:pt idx="2">
                    <c:v>20.201241894839463</c:v>
                  </c:pt>
                  <c:pt idx="3">
                    <c:v>15.372115064635762</c:v>
                  </c:pt>
                  <c:pt idx="4">
                    <c:v>21.16941419698319</c:v>
                  </c:pt>
                </c:numCache>
              </c:numRef>
            </c:plus>
            <c:minus>
              <c:numRef>
                <c:f>'figure 6 '!$I$113:$M$113</c:f>
                <c:numCache>
                  <c:formatCode>General</c:formatCode>
                  <c:ptCount val="5"/>
                  <c:pt idx="0">
                    <c:v>10.600451086119579</c:v>
                  </c:pt>
                  <c:pt idx="1">
                    <c:v>11.589454873839351</c:v>
                  </c:pt>
                  <c:pt idx="2">
                    <c:v>20.201241894839463</c:v>
                  </c:pt>
                  <c:pt idx="3">
                    <c:v>15.372115064635762</c:v>
                  </c:pt>
                  <c:pt idx="4">
                    <c:v>21.16941419698319</c:v>
                  </c:pt>
                </c:numCache>
              </c:numRef>
            </c:minus>
          </c:errBars>
          <c:xVal>
            <c:numRef>
              <c:f>'figure 6 '!$B$109:$F$109</c:f>
              <c:numCache>
                <c:formatCode>General</c:formatCode>
                <c:ptCount val="5"/>
                <c:pt idx="0">
                  <c:v>6</c:v>
                </c:pt>
                <c:pt idx="1">
                  <c:v>16</c:v>
                </c:pt>
                <c:pt idx="2">
                  <c:v>30</c:v>
                </c:pt>
                <c:pt idx="3">
                  <c:v>40</c:v>
                </c:pt>
                <c:pt idx="4">
                  <c:v>54</c:v>
                </c:pt>
              </c:numCache>
            </c:numRef>
          </c:xVal>
          <c:yVal>
            <c:numRef>
              <c:f>'figure 6 '!$B$113:$F$113</c:f>
              <c:numCache>
                <c:formatCode>0.0</c:formatCode>
                <c:ptCount val="5"/>
                <c:pt idx="0">
                  <c:v>38.914892615644639</c:v>
                </c:pt>
                <c:pt idx="1">
                  <c:v>71.325905386257418</c:v>
                </c:pt>
                <c:pt idx="2">
                  <c:v>80.438426387306336</c:v>
                </c:pt>
                <c:pt idx="3">
                  <c:v>76.438211733869238</c:v>
                </c:pt>
                <c:pt idx="4">
                  <c:v>128.4684861098979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7812264"/>
        <c:axId val="227440744"/>
      </c:scatterChart>
      <c:valAx>
        <c:axId val="187812264"/>
        <c:scaling>
          <c:orientation val="minMax"/>
          <c:max val="60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sz="1000" b="0"/>
                </a:pPr>
                <a:r>
                  <a:rPr lang="en-US" sz="1000" b="0" dirty="0"/>
                  <a:t>H</a:t>
                </a:r>
                <a:r>
                  <a:rPr lang="en-US" sz="1000" b="0" dirty="0" smtClean="0"/>
                  <a:t>ours</a:t>
                </a:r>
                <a:endParaRPr lang="en-US" sz="1000" b="0" dirty="0"/>
              </a:p>
            </c:rich>
          </c:tx>
          <c:layout>
            <c:manualLayout>
              <c:xMode val="edge"/>
              <c:yMode val="edge"/>
              <c:x val="0.47954131084637069"/>
              <c:y val="0.93765377071958345"/>
            </c:manualLayout>
          </c:layout>
          <c:overlay val="0"/>
        </c:title>
        <c:numFmt formatCode="General" sourceLinked="1"/>
        <c:majorTickMark val="cross"/>
        <c:minorTickMark val="out"/>
        <c:tickLblPos val="nextTo"/>
        <c:crossAx val="227440744"/>
        <c:crosses val="autoZero"/>
        <c:crossBetween val="midCat"/>
        <c:majorUnit val="6"/>
        <c:minorUnit val="2"/>
      </c:valAx>
      <c:valAx>
        <c:axId val="227440744"/>
        <c:scaling>
          <c:orientation val="minMax"/>
          <c:max val="22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 dirty="0"/>
                  <a:t>FFA (</a:t>
                </a:r>
                <a:r>
                  <a:rPr lang="en-US" b="0" dirty="0" smtClean="0"/>
                  <a:t>µg/million</a:t>
                </a:r>
                <a:r>
                  <a:rPr lang="en-US" b="0" baseline="0" dirty="0" smtClean="0"/>
                  <a:t> </a:t>
                </a:r>
                <a:r>
                  <a:rPr lang="en-US" b="0" dirty="0" smtClean="0"/>
                  <a:t>cells)</a:t>
                </a:r>
                <a:endParaRPr lang="en-US" b="0" dirty="0"/>
              </a:p>
            </c:rich>
          </c:tx>
          <c:layout>
            <c:manualLayout>
              <c:xMode val="edge"/>
              <c:yMode val="edge"/>
              <c:x val="9.8005817313474835E-3"/>
              <c:y val="0.28904883319615926"/>
            </c:manualLayout>
          </c:layout>
          <c:overlay val="0"/>
        </c:title>
        <c:numFmt formatCode="0" sourceLinked="0"/>
        <c:majorTickMark val="out"/>
        <c:minorTickMark val="out"/>
        <c:tickLblPos val="nextTo"/>
        <c:crossAx val="187812264"/>
        <c:crosses val="autoZero"/>
        <c:crossBetween val="midCat"/>
        <c:majorUnit val="50"/>
        <c:minorUnit val="10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2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86848</cdr:x>
      <cdr:y>0.35134</cdr:y>
    </cdr:from>
    <cdr:to>
      <cdr:x>0.94401</cdr:x>
      <cdr:y>0.41736</cdr:y>
    </cdr:to>
    <cdr:sp macro="" textlink="">
      <cdr:nvSpPr>
        <cdr:cNvPr id="5" name="TextBox 1"/>
        <cdr:cNvSpPr txBox="1"/>
      </cdr:nvSpPr>
      <cdr:spPr>
        <a:xfrm xmlns:a="http://schemas.openxmlformats.org/drawingml/2006/main">
          <a:off x="4736741" y="1037754"/>
          <a:ext cx="411946" cy="19500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marL="0" marR="0" indent="0" defTabSz="91440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r>
            <a:rPr lang="en-US" sz="1200" b="0" dirty="0">
              <a:latin typeface="Times New Roman" panose="02020603050405020304" pitchFamily="18" charset="0"/>
              <a:cs typeface="Times New Roman" panose="02020603050405020304" pitchFamily="18" charset="0"/>
            </a:rPr>
            <a:t>LL 35</a:t>
          </a:r>
          <a:r>
            <a:rPr lang="en-US" sz="1200" b="0" dirty="0">
              <a:effectLst/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°C</a:t>
          </a:r>
          <a:endParaRPr lang="en-US" sz="1200" b="0" dirty="0">
            <a:effectLst/>
            <a:latin typeface="Times New Roman" panose="02020603050405020304" pitchFamily="18" charset="0"/>
            <a:cs typeface="Times New Roman" panose="02020603050405020304" pitchFamily="18" charset="0"/>
          </a:endParaRPr>
        </a:p>
        <a:p xmlns:a="http://schemas.openxmlformats.org/drawingml/2006/main">
          <a:endParaRPr lang="en-US" sz="1200" b="0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 xmlns:a="http://schemas.openxmlformats.org/drawingml/2006/main">
          <a:endParaRPr lang="en-US" sz="1200" b="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86797</cdr:x>
      <cdr:y>0.48047</cdr:y>
    </cdr:from>
    <cdr:to>
      <cdr:x>0.9435</cdr:x>
      <cdr:y>0.54649</cdr:y>
    </cdr:to>
    <cdr:sp macro="" textlink="">
      <cdr:nvSpPr>
        <cdr:cNvPr id="7" name="TextBox 1"/>
        <cdr:cNvSpPr txBox="1"/>
      </cdr:nvSpPr>
      <cdr:spPr>
        <a:xfrm xmlns:a="http://schemas.openxmlformats.org/drawingml/2006/main">
          <a:off x="5977363" y="2574925"/>
          <a:ext cx="520143" cy="35381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marL="0" marR="0" indent="0" defTabSz="91440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r>
            <a:rPr lang="en-US" sz="1200" b="0" dirty="0">
              <a:latin typeface="Times New Roman" panose="02020603050405020304" pitchFamily="18" charset="0"/>
              <a:cs typeface="Times New Roman" panose="02020603050405020304" pitchFamily="18" charset="0"/>
            </a:rPr>
            <a:t>LL 25</a:t>
          </a:r>
          <a:r>
            <a:rPr lang="en-US" sz="1200" b="0" dirty="0">
              <a:effectLst/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°C</a:t>
          </a:r>
          <a:endParaRPr lang="en-US" sz="1200" b="0" dirty="0">
            <a:effectLst/>
            <a:latin typeface="Times New Roman" panose="02020603050405020304" pitchFamily="18" charset="0"/>
            <a:cs typeface="Times New Roman" panose="02020603050405020304" pitchFamily="18" charset="0"/>
          </a:endParaRPr>
        </a:p>
        <a:p xmlns:a="http://schemas.openxmlformats.org/drawingml/2006/main">
          <a:endParaRPr lang="en-US" sz="1200" b="0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 xmlns:a="http://schemas.openxmlformats.org/drawingml/2006/main">
          <a:endParaRPr lang="en-US" sz="1200" b="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86848</cdr:x>
      <cdr:y>0.71252</cdr:y>
    </cdr:from>
    <cdr:to>
      <cdr:x>0.93834</cdr:x>
      <cdr:y>0.80434</cdr:y>
    </cdr:to>
    <cdr:sp macro="" textlink="">
      <cdr:nvSpPr>
        <cdr:cNvPr id="8" name="TextBox 1"/>
        <cdr:cNvSpPr txBox="1"/>
      </cdr:nvSpPr>
      <cdr:spPr>
        <a:xfrm xmlns:a="http://schemas.openxmlformats.org/drawingml/2006/main">
          <a:off x="4736742" y="2104554"/>
          <a:ext cx="381000" cy="27120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marL="0" marR="0" indent="0" defTabSz="91440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r>
            <a:rPr lang="en-US" sz="1200" b="0" dirty="0">
              <a:latin typeface="Times New Roman" panose="02020603050405020304" pitchFamily="18" charset="0"/>
              <a:cs typeface="Times New Roman" panose="02020603050405020304" pitchFamily="18" charset="0"/>
            </a:rPr>
            <a:t>LD 25</a:t>
          </a:r>
          <a:r>
            <a:rPr lang="en-US" sz="1200" b="0" dirty="0">
              <a:effectLst/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°C</a:t>
          </a:r>
          <a:endParaRPr lang="en-US" sz="1200" b="0" dirty="0">
            <a:effectLst/>
            <a:latin typeface="Times New Roman" panose="02020603050405020304" pitchFamily="18" charset="0"/>
            <a:cs typeface="Times New Roman" panose="02020603050405020304" pitchFamily="18" charset="0"/>
          </a:endParaRPr>
        </a:p>
        <a:p xmlns:a="http://schemas.openxmlformats.org/drawingml/2006/main">
          <a:endParaRPr lang="en-US" sz="1200" b="0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 xmlns:a="http://schemas.openxmlformats.org/drawingml/2006/main">
          <a:endParaRPr lang="en-US" sz="1200" b="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86906</cdr:x>
      <cdr:y>0.61555</cdr:y>
    </cdr:from>
    <cdr:to>
      <cdr:x>0.94459</cdr:x>
      <cdr:y>0.68157</cdr:y>
    </cdr:to>
    <cdr:sp macro="" textlink="">
      <cdr:nvSpPr>
        <cdr:cNvPr id="9" name="TextBox 1"/>
        <cdr:cNvSpPr txBox="1"/>
      </cdr:nvSpPr>
      <cdr:spPr>
        <a:xfrm xmlns:a="http://schemas.openxmlformats.org/drawingml/2006/main">
          <a:off x="5984875" y="3298825"/>
          <a:ext cx="520143" cy="35381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marL="0" marR="0" indent="0" defTabSz="91440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r>
            <a:rPr lang="en-US" sz="1200" b="0" dirty="0">
              <a:latin typeface="Times New Roman" panose="02020603050405020304" pitchFamily="18" charset="0"/>
              <a:cs typeface="Times New Roman" panose="02020603050405020304" pitchFamily="18" charset="0"/>
            </a:rPr>
            <a:t>LD 35</a:t>
          </a:r>
          <a:r>
            <a:rPr lang="en-US" sz="1200" b="0" dirty="0">
              <a:effectLst/>
              <a:latin typeface="Times New Roman" panose="02020603050405020304" pitchFamily="18" charset="0"/>
              <a:ea typeface="+mn-ea"/>
              <a:cs typeface="Times New Roman" panose="02020603050405020304" pitchFamily="18" charset="0"/>
            </a:rPr>
            <a:t>°C</a:t>
          </a:r>
          <a:endParaRPr lang="en-US" sz="1200" b="0" dirty="0">
            <a:effectLst/>
            <a:latin typeface="Times New Roman" panose="02020603050405020304" pitchFamily="18" charset="0"/>
            <a:cs typeface="Times New Roman" panose="02020603050405020304" pitchFamily="18" charset="0"/>
          </a:endParaRPr>
        </a:p>
        <a:p xmlns:a="http://schemas.openxmlformats.org/drawingml/2006/main">
          <a:endParaRPr lang="en-US" sz="1200" b="0" dirty="0">
            <a:latin typeface="Times New Roman" panose="02020603050405020304" pitchFamily="18" charset="0"/>
            <a:cs typeface="Times New Roman" panose="02020603050405020304" pitchFamily="18" charset="0"/>
          </a:endParaRPr>
        </a:p>
        <a:p xmlns:a="http://schemas.openxmlformats.org/drawingml/2006/main">
          <a:endParaRPr lang="en-US" sz="1200" b="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12574</cdr:x>
      <cdr:y>0.02356</cdr:y>
    </cdr:from>
    <cdr:to>
      <cdr:x>0.35787</cdr:x>
      <cdr:y>0.14496</cdr:y>
    </cdr:to>
    <cdr:sp macro="" textlink="">
      <cdr:nvSpPr>
        <cdr:cNvPr id="11" name="TextBox 5"/>
        <cdr:cNvSpPr txBox="1"/>
      </cdr:nvSpPr>
      <cdr:spPr>
        <a:xfrm xmlns:a="http://schemas.openxmlformats.org/drawingml/2006/main">
          <a:off x="685800" y="69588"/>
          <a:ext cx="1266051" cy="35857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US" sz="1200" b="0" dirty="0">
            <a:latin typeface="Times New Roman" pitchFamily="18" charset="0"/>
            <a:cs typeface="Times New Roman" pitchFamily="18" charset="0"/>
          </a:endParaRP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9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F0638EF7-21BA-46D6-B331-2665E60F3993}" type="datetimeFigureOut">
              <a:rPr lang="en-US" smtClean="0"/>
              <a:pPr/>
              <a:t>2/24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7100" y="696913"/>
            <a:ext cx="2616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1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9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8A23745D-2A52-4D76-8184-F020C4DF11F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62635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A23745D-2A52-4D76-8184-F020C4DF11F2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760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4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4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4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078704-86FC-4871-8292-C5A59EA7DC58}" type="datetimeFigureOut">
              <a:rPr lang="en-US" smtClean="0"/>
              <a:pPr/>
              <a:t>2/2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7" name="Group 36"/>
          <p:cNvGrpSpPr/>
          <p:nvPr/>
        </p:nvGrpSpPr>
        <p:grpSpPr>
          <a:xfrm>
            <a:off x="549590" y="143665"/>
            <a:ext cx="6019800" cy="7498421"/>
            <a:chOff x="549590" y="143665"/>
            <a:chExt cx="6019800" cy="7498421"/>
          </a:xfrm>
        </p:grpSpPr>
        <p:grpSp>
          <p:nvGrpSpPr>
            <p:cNvPr id="27" name="Group 26"/>
            <p:cNvGrpSpPr/>
            <p:nvPr/>
          </p:nvGrpSpPr>
          <p:grpSpPr>
            <a:xfrm>
              <a:off x="549590" y="143665"/>
              <a:ext cx="6019800" cy="7498421"/>
              <a:chOff x="549590" y="143665"/>
              <a:chExt cx="6019800" cy="7498421"/>
            </a:xfrm>
          </p:grpSpPr>
          <p:graphicFrame>
            <p:nvGraphicFramePr>
              <p:cNvPr id="10" name="Chart 9"/>
              <p:cNvGraphicFramePr/>
              <p:nvPr>
                <p:extLst>
                  <p:ext uri="{D42A27DB-BD31-4B8C-83A1-F6EECF244321}">
                    <p14:modId xmlns:p14="http://schemas.microsoft.com/office/powerpoint/2010/main" val="2838967538"/>
                  </p:ext>
                </p:extLst>
              </p:nvPr>
            </p:nvGraphicFramePr>
            <p:xfrm>
              <a:off x="701990" y="3351234"/>
              <a:ext cx="5638800" cy="33528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7" name="TextBox 6"/>
              <p:cNvSpPr txBox="1"/>
              <p:nvPr/>
            </p:nvSpPr>
            <p:spPr>
              <a:xfrm>
                <a:off x="549590" y="6934200"/>
                <a:ext cx="6019800" cy="7078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sz="1000" b="1" dirty="0" smtClean="0">
                    <a:latin typeface="Times New Roman" pitchFamily="18" charset="0"/>
                    <a:cs typeface="Times New Roman" pitchFamily="18" charset="0"/>
                  </a:rPr>
                  <a:t>S</a:t>
                </a:r>
                <a:r>
                  <a:rPr lang="en-US" sz="1000" b="1" dirty="0">
                    <a:latin typeface="Times New Roman" pitchFamily="18" charset="0"/>
                    <a:cs typeface="Times New Roman" pitchFamily="18" charset="0"/>
                  </a:rPr>
                  <a:t>7</a:t>
                </a:r>
                <a:r>
                  <a:rPr lang="en-US" sz="1000" b="1" dirty="0" smtClean="0">
                    <a:latin typeface="Times New Roman" pitchFamily="18" charset="0"/>
                    <a:cs typeface="Times New Roman" pitchFamily="18" charset="0"/>
                  </a:rPr>
                  <a:t> Figure. Free fatty acids content increases at </a:t>
                </a:r>
                <a:r>
                  <a:rPr lang="en-US" sz="1000" b="1" dirty="0">
                    <a:latin typeface="Times New Roman" pitchFamily="18" charset="0"/>
                    <a:cs typeface="Times New Roman" pitchFamily="18" charset="0"/>
                  </a:rPr>
                  <a:t>higher temperature under continuous </a:t>
                </a:r>
                <a:r>
                  <a:rPr lang="en-US" sz="1000" b="1" dirty="0" smtClean="0">
                    <a:latin typeface="Times New Roman" pitchFamily="18" charset="0"/>
                    <a:cs typeface="Times New Roman" pitchFamily="18" charset="0"/>
                  </a:rPr>
                  <a:t>light (A) and less saturated fatty acids are present in the FFA fraction (B). </a:t>
                </a:r>
                <a:r>
                  <a:rPr lang="en-US" sz="1000" dirty="0" smtClean="0">
                    <a:latin typeface="Times New Roman" pitchFamily="18" charset="0"/>
                    <a:cs typeface="Times New Roman" pitchFamily="18" charset="0"/>
                  </a:rPr>
                  <a:t>The </a:t>
                </a:r>
                <a:r>
                  <a:rPr lang="en-US" sz="1000" dirty="0">
                    <a:latin typeface="Times New Roman" pitchFamily="18" charset="0"/>
                    <a:cs typeface="Times New Roman" pitchFamily="18" charset="0"/>
                  </a:rPr>
                  <a:t>error bars represent the standard deviation from three </a:t>
                </a:r>
                <a:r>
                  <a:rPr lang="en-US" sz="1000" dirty="0" smtClean="0">
                    <a:latin typeface="Times New Roman" pitchFamily="18" charset="0"/>
                    <a:cs typeface="Times New Roman" pitchFamily="18" charset="0"/>
                  </a:rPr>
                  <a:t>independent biological </a:t>
                </a:r>
                <a:r>
                  <a:rPr lang="en-US" sz="1000" dirty="0">
                    <a:latin typeface="Times New Roman" pitchFamily="18" charset="0"/>
                    <a:cs typeface="Times New Roman" pitchFamily="18" charset="0"/>
                  </a:rPr>
                  <a:t>replicates. </a:t>
                </a:r>
                <a:r>
                  <a:rPr lang="en-US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tatistical significance was assessed by unpaired, two-tailed, Student’s </a:t>
                </a:r>
                <a:r>
                  <a:rPr lang="en-US" sz="10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-</a:t>
                </a:r>
                <a:r>
                  <a:rPr lang="en-US" sz="1000" dirty="0">
                    <a:latin typeface="Times New Roman" pitchFamily="18" charset="0"/>
                    <a:cs typeface="Times New Roman" pitchFamily="18" charset="0"/>
                  </a:rPr>
                  <a:t>test. The </a:t>
                </a:r>
                <a:r>
                  <a:rPr lang="en-US" sz="1000" dirty="0">
                    <a:latin typeface="Times New Roman" pitchFamily="18" charset="0"/>
                    <a:cs typeface="Times New Roman" pitchFamily="18" charset="0"/>
                  </a:rPr>
                  <a:t>values with different letters are significantly different at 54 </a:t>
                </a:r>
                <a:r>
                  <a:rPr lang="en-US" sz="1000" dirty="0" err="1">
                    <a:latin typeface="Times New Roman" pitchFamily="18" charset="0"/>
                    <a:cs typeface="Times New Roman" pitchFamily="18" charset="0"/>
                  </a:rPr>
                  <a:t>hrs</a:t>
                </a:r>
                <a:r>
                  <a:rPr lang="en-US" sz="1000" dirty="0">
                    <a:latin typeface="Times New Roman" pitchFamily="18" charset="0"/>
                    <a:cs typeface="Times New Roman" pitchFamily="18" charset="0"/>
                  </a:rPr>
                  <a:t> (</a:t>
                </a:r>
                <a:r>
                  <a:rPr lang="en-US" sz="1000" dirty="0" smtClean="0">
                    <a:latin typeface="Times New Roman" pitchFamily="18" charset="0"/>
                    <a:cs typeface="Times New Roman" pitchFamily="18" charset="0"/>
                  </a:rPr>
                  <a:t>p&lt;0.05).</a:t>
                </a:r>
                <a:endParaRPr lang="en-US" sz="1000" dirty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616522" y="3173892"/>
                <a:ext cx="29558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Times New Roman" pitchFamily="18" charset="0"/>
                    <a:cs typeface="Times New Roman" pitchFamily="18" charset="0"/>
                  </a:rPr>
                  <a:t>B</a:t>
                </a: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616523" y="257646"/>
                <a:ext cx="29558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 smtClean="0">
                    <a:latin typeface="Times New Roman" pitchFamily="18" charset="0"/>
                    <a:cs typeface="Times New Roman" pitchFamily="18" charset="0"/>
                  </a:rPr>
                  <a:t>A</a:t>
                </a:r>
                <a:endParaRPr lang="en-US" sz="10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grpSp>
            <p:nvGrpSpPr>
              <p:cNvPr id="17" name="Group 16"/>
              <p:cNvGrpSpPr/>
              <p:nvPr/>
            </p:nvGrpSpPr>
            <p:grpSpPr>
              <a:xfrm>
                <a:off x="749659" y="143665"/>
                <a:ext cx="5454064" cy="3067648"/>
                <a:chOff x="749659" y="143665"/>
                <a:chExt cx="5454064" cy="3067648"/>
              </a:xfrm>
            </p:grpSpPr>
            <p:sp>
              <p:nvSpPr>
                <p:cNvPr id="12" name="Rectangle 11"/>
                <p:cNvSpPr/>
                <p:nvPr/>
              </p:nvSpPr>
              <p:spPr>
                <a:xfrm>
                  <a:off x="4097290" y="143665"/>
                  <a:ext cx="931910" cy="2675735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3" name="Rectangle 12"/>
                <p:cNvSpPr/>
                <p:nvPr/>
              </p:nvSpPr>
              <p:spPr>
                <a:xfrm>
                  <a:off x="2334108" y="152401"/>
                  <a:ext cx="866292" cy="2667000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graphicFrame>
              <p:nvGraphicFramePr>
                <p:cNvPr id="19" name="Chart 18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2933658644"/>
                    </p:ext>
                  </p:extLst>
                </p:nvPr>
              </p:nvGraphicFramePr>
              <p:xfrm>
                <a:off x="749659" y="257646"/>
                <a:ext cx="5454064" cy="2953667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4"/>
                </a:graphicData>
              </a:graphic>
            </p:graphicFrame>
            <p:sp>
              <p:nvSpPr>
                <p:cNvPr id="14" name="Straight Arrow Connector 13"/>
                <p:cNvSpPr/>
                <p:nvPr/>
              </p:nvSpPr>
              <p:spPr>
                <a:xfrm>
                  <a:off x="3200400" y="1295400"/>
                  <a:ext cx="0" cy="412819"/>
                </a:xfrm>
                <a:prstGeom prst="straightConnector1">
                  <a:avLst/>
                </a:prstGeom>
                <a:ln w="2540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/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endParaRPr lang="en-US" sz="100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</p:grpSp>
        <p:sp>
          <p:nvSpPr>
            <p:cNvPr id="18" name="TextBox 17"/>
            <p:cNvSpPr txBox="1"/>
            <p:nvPr/>
          </p:nvSpPr>
          <p:spPr>
            <a:xfrm>
              <a:off x="5261658" y="1125379"/>
              <a:ext cx="2247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b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5246225" y="1569079"/>
              <a:ext cx="2247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b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5246225" y="2309854"/>
              <a:ext cx="2247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a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5257800" y="1931754"/>
              <a:ext cx="2247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a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6053558" y="3886200"/>
              <a:ext cx="2247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c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5955175" y="5773579"/>
              <a:ext cx="2247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c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4590325" y="5943601"/>
              <a:ext cx="3511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latin typeface="Times New Roman" pitchFamily="18" charset="0"/>
                  <a:cs typeface="Times New Roman" pitchFamily="18" charset="0"/>
                </a:rPr>
                <a:t>a,c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4762983" y="5310850"/>
              <a:ext cx="2247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d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3322900" y="5890550"/>
              <a:ext cx="3511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latin typeface="Times New Roman" pitchFamily="18" charset="0"/>
                  <a:cs typeface="Times New Roman" pitchFamily="18" charset="0"/>
                </a:rPr>
                <a:t>a,c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3452150" y="4530525"/>
              <a:ext cx="3511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b,c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2198225" y="5099354"/>
              <a:ext cx="3511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latin typeface="Times New Roman" pitchFamily="18" charset="0"/>
                  <a:cs typeface="Times New Roman" pitchFamily="18" charset="0"/>
                </a:rPr>
                <a:t>a,d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2122025" y="5972279"/>
              <a:ext cx="2401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Times New Roman" pitchFamily="18" charset="0"/>
                  <a:cs typeface="Times New Roman" pitchFamily="18" charset="0"/>
                </a:rPr>
                <a:t>a</a:t>
              </a:r>
              <a:endParaRPr lang="en-US" sz="10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3608608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454</TotalTime>
  <Words>107</Words>
  <Application>Microsoft Office PowerPoint</Application>
  <PresentationFormat>On-screen Show (4:3)</PresentationFormat>
  <Paragraphs>2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Helvetica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wsedero</dc:creator>
  <cp:lastModifiedBy>Soundarya Srirangan</cp:lastModifiedBy>
  <cp:revision>489</cp:revision>
  <cp:lastPrinted>2014-10-28T12:32:56Z</cp:lastPrinted>
  <dcterms:created xsi:type="dcterms:W3CDTF">2012-07-19T19:41:05Z</dcterms:created>
  <dcterms:modified xsi:type="dcterms:W3CDTF">2015-02-24T14:37:12Z</dcterms:modified>
</cp:coreProperties>
</file>